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49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586894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40064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82478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33126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968826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86682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5134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45390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65353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76405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13830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EDAB4-4551-4817-8C19-3255EE6CBD01}" type="datetimeFigureOut">
              <a:rPr lang="en-GB" smtClean="0"/>
              <a:pPr/>
              <a:t>30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843FF-1BD7-4C4F-AEC0-E00585D3C3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94442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80271" y="5708279"/>
            <a:ext cx="2603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33281" y="5675103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51521" y="585866"/>
            <a:ext cx="7159234" cy="5380002"/>
            <a:chOff x="251521" y="585866"/>
            <a:chExt cx="7159234" cy="538000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1111" r="89688" b="19509"/>
            <a:stretch/>
          </p:blipFill>
          <p:spPr bwMode="auto">
            <a:xfrm>
              <a:off x="251521" y="585866"/>
              <a:ext cx="1008111" cy="50753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613" t="12103" r="60845" b="15151"/>
            <a:stretch/>
          </p:blipFill>
          <p:spPr bwMode="auto">
            <a:xfrm>
              <a:off x="1015898" y="644402"/>
              <a:ext cx="3193144" cy="53214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5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965" t="14881" r="59977" b="13096"/>
            <a:stretch/>
          </p:blipFill>
          <p:spPr bwMode="auto">
            <a:xfrm>
              <a:off x="4275669" y="678841"/>
              <a:ext cx="3135086" cy="52686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xmlns="" val="27186706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50703" y="592978"/>
            <a:ext cx="7392382" cy="5427496"/>
            <a:chOff x="350703" y="592978"/>
            <a:chExt cx="7392382" cy="5427496"/>
          </a:xfrm>
        </p:grpSpPr>
        <p:pic>
          <p:nvPicPr>
            <p:cNvPr id="2054" name="Picture 6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" t="16071" r="91907" b="14286"/>
            <a:stretch/>
          </p:blipFill>
          <p:spPr bwMode="auto">
            <a:xfrm>
              <a:off x="350703" y="638741"/>
              <a:ext cx="1052945" cy="5094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6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694" t="16071" r="60734" b="9849"/>
            <a:stretch/>
          </p:blipFill>
          <p:spPr bwMode="auto">
            <a:xfrm>
              <a:off x="1371582" y="601367"/>
              <a:ext cx="3197102" cy="5419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725" t="18452" r="60957" b="8712"/>
            <a:stretch/>
          </p:blipFill>
          <p:spPr bwMode="auto">
            <a:xfrm>
              <a:off x="4578971" y="592978"/>
              <a:ext cx="3164114" cy="5328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0" name="TextBox 9"/>
          <p:cNvSpPr txBox="1"/>
          <p:nvPr/>
        </p:nvSpPr>
        <p:spPr>
          <a:xfrm>
            <a:off x="1159914" y="5722134"/>
            <a:ext cx="385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3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648833" y="5691691"/>
            <a:ext cx="385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4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687974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7504" y="692696"/>
            <a:ext cx="7461122" cy="5458753"/>
            <a:chOff x="107504" y="692696"/>
            <a:chExt cx="7461122" cy="5458753"/>
          </a:xfrm>
        </p:grpSpPr>
        <p:pic>
          <p:nvPicPr>
            <p:cNvPr id="3075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-56" t="18778" r="92136" b="10317"/>
            <a:stretch/>
          </p:blipFill>
          <p:spPr bwMode="auto">
            <a:xfrm>
              <a:off x="107504" y="692696"/>
              <a:ext cx="1030514" cy="51868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837" t="21230" r="60355" b="6127"/>
            <a:stretch/>
          </p:blipFill>
          <p:spPr bwMode="auto">
            <a:xfrm>
              <a:off x="1166993" y="837484"/>
              <a:ext cx="3227815" cy="5313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502" t="9524" r="60859" b="18687"/>
            <a:stretch/>
          </p:blipFill>
          <p:spPr bwMode="auto">
            <a:xfrm>
              <a:off x="4362871" y="899914"/>
              <a:ext cx="3205755" cy="52515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TextBox 6"/>
          <p:cNvSpPr txBox="1"/>
          <p:nvPr/>
        </p:nvSpPr>
        <p:spPr>
          <a:xfrm>
            <a:off x="841439" y="5913371"/>
            <a:ext cx="385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5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443931" y="5891127"/>
            <a:ext cx="385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6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0611771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51520" y="757065"/>
            <a:ext cx="7433412" cy="5379246"/>
            <a:chOff x="251520" y="757065"/>
            <a:chExt cx="7433412" cy="5379246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0119" r="91849" b="20872"/>
            <a:stretch/>
          </p:blipFill>
          <p:spPr bwMode="auto">
            <a:xfrm>
              <a:off x="251520" y="757065"/>
              <a:ext cx="1060501" cy="50481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851" t="10701" r="60762" b="16003"/>
            <a:stretch/>
          </p:blipFill>
          <p:spPr bwMode="auto">
            <a:xfrm>
              <a:off x="1332767" y="759297"/>
              <a:ext cx="3172691" cy="53617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613" t="13447" r="60845" b="13690"/>
            <a:stretch/>
          </p:blipFill>
          <p:spPr bwMode="auto">
            <a:xfrm>
              <a:off x="4491789" y="806269"/>
              <a:ext cx="3193143" cy="53300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TextBox 6"/>
          <p:cNvSpPr txBox="1"/>
          <p:nvPr/>
        </p:nvSpPr>
        <p:spPr>
          <a:xfrm>
            <a:off x="1013165" y="5874539"/>
            <a:ext cx="385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7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571359" y="5877272"/>
            <a:ext cx="385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8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2415687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4105" y="824981"/>
            <a:ext cx="7368537" cy="5412331"/>
            <a:chOff x="344105" y="824981"/>
            <a:chExt cx="7368537" cy="5412331"/>
          </a:xfrm>
        </p:grpSpPr>
        <p:pic>
          <p:nvPicPr>
            <p:cNvPr id="5124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3889" r="91857" b="17045"/>
            <a:stretch/>
          </p:blipFill>
          <p:spPr bwMode="auto">
            <a:xfrm>
              <a:off x="344105" y="824981"/>
              <a:ext cx="1059543" cy="5052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837" t="14286" r="60589" b="11932"/>
            <a:stretch/>
          </p:blipFill>
          <p:spPr bwMode="auto">
            <a:xfrm>
              <a:off x="1374629" y="839977"/>
              <a:ext cx="3197371" cy="5397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725" t="17045" r="60845" b="9920"/>
            <a:stretch/>
          </p:blipFill>
          <p:spPr bwMode="auto">
            <a:xfrm>
              <a:off x="4534014" y="878277"/>
              <a:ext cx="3178628" cy="53425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TextBox 6"/>
          <p:cNvSpPr txBox="1"/>
          <p:nvPr/>
        </p:nvSpPr>
        <p:spPr>
          <a:xfrm>
            <a:off x="1017503" y="5943764"/>
            <a:ext cx="3861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9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601802" y="5974634"/>
            <a:ext cx="3861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0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713591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45142" y="922059"/>
            <a:ext cx="7441959" cy="5373406"/>
            <a:chOff x="445142" y="922059"/>
            <a:chExt cx="7441959" cy="5373406"/>
          </a:xfrm>
        </p:grpSpPr>
        <p:pic>
          <p:nvPicPr>
            <p:cNvPr id="6147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9848" r="92080" b="21428"/>
            <a:stretch/>
          </p:blipFill>
          <p:spPr bwMode="auto">
            <a:xfrm>
              <a:off x="445142" y="922059"/>
              <a:ext cx="1030514" cy="5027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837" t="10516" r="60885" b="16666"/>
            <a:stretch/>
          </p:blipFill>
          <p:spPr bwMode="auto">
            <a:xfrm>
              <a:off x="1524004" y="968721"/>
              <a:ext cx="3158836" cy="53267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725" t="12500" r="60733" b="14484"/>
            <a:stretch/>
          </p:blipFill>
          <p:spPr bwMode="auto">
            <a:xfrm>
              <a:off x="4693958" y="942110"/>
              <a:ext cx="3193143" cy="5341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8" name="TextBox 7"/>
          <p:cNvSpPr txBox="1"/>
          <p:nvPr/>
        </p:nvSpPr>
        <p:spPr>
          <a:xfrm>
            <a:off x="1228061" y="6035389"/>
            <a:ext cx="3861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1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852616" y="6049244"/>
            <a:ext cx="3861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2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8205889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16113" y="836712"/>
            <a:ext cx="7387020" cy="5328561"/>
            <a:chOff x="416113" y="836712"/>
            <a:chExt cx="7387020" cy="5328561"/>
          </a:xfrm>
        </p:grpSpPr>
        <p:pic>
          <p:nvPicPr>
            <p:cNvPr id="7171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5079" r="91857" b="16857"/>
            <a:stretch/>
          </p:blipFill>
          <p:spPr bwMode="auto">
            <a:xfrm>
              <a:off x="416113" y="836712"/>
              <a:ext cx="1059543" cy="49790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725" t="15080" r="60952" b="12078"/>
            <a:stretch/>
          </p:blipFill>
          <p:spPr bwMode="auto">
            <a:xfrm>
              <a:off x="1459423" y="836712"/>
              <a:ext cx="3164726" cy="53285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725" t="17460" r="60845" b="10118"/>
            <a:stretch/>
          </p:blipFill>
          <p:spPr bwMode="auto">
            <a:xfrm>
              <a:off x="4624505" y="836712"/>
              <a:ext cx="3178628" cy="52977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TextBox 6"/>
          <p:cNvSpPr txBox="1"/>
          <p:nvPr/>
        </p:nvSpPr>
        <p:spPr>
          <a:xfrm>
            <a:off x="1163758" y="5926133"/>
            <a:ext cx="3861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3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650715" y="5921570"/>
            <a:ext cx="3861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4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624971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44105" y="841828"/>
            <a:ext cx="7378280" cy="5378154"/>
            <a:chOff x="344105" y="841828"/>
            <a:chExt cx="7378280" cy="5378154"/>
          </a:xfrm>
        </p:grpSpPr>
        <p:pic>
          <p:nvPicPr>
            <p:cNvPr id="8195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1508" r="91857" b="19508"/>
            <a:stretch/>
          </p:blipFill>
          <p:spPr bwMode="auto">
            <a:xfrm>
              <a:off x="344105" y="841828"/>
              <a:ext cx="1059543" cy="50463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948" t="12302" r="60922" b="14936"/>
            <a:stretch/>
          </p:blipFill>
          <p:spPr bwMode="auto">
            <a:xfrm>
              <a:off x="1404183" y="897248"/>
              <a:ext cx="3139574" cy="53227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725" t="14772" r="60845" b="12500"/>
            <a:stretch/>
          </p:blipFill>
          <p:spPr bwMode="auto">
            <a:xfrm>
              <a:off x="4543757" y="899837"/>
              <a:ext cx="3178628" cy="5320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TextBox 6"/>
          <p:cNvSpPr txBox="1"/>
          <p:nvPr/>
        </p:nvSpPr>
        <p:spPr>
          <a:xfrm>
            <a:off x="1677825" y="5990845"/>
            <a:ext cx="3861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5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597941" y="5990845"/>
            <a:ext cx="3861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76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5244692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394108" y="404664"/>
            <a:ext cx="7562268" cy="5371514"/>
            <a:chOff x="257583" y="908720"/>
            <a:chExt cx="7562268" cy="5371514"/>
          </a:xfrm>
        </p:grpSpPr>
        <p:grpSp>
          <p:nvGrpSpPr>
            <p:cNvPr id="3" name="Group 2"/>
            <p:cNvGrpSpPr/>
            <p:nvPr/>
          </p:nvGrpSpPr>
          <p:grpSpPr>
            <a:xfrm>
              <a:off x="257583" y="908720"/>
              <a:ext cx="7369196" cy="5371514"/>
              <a:chOff x="257583" y="908720"/>
              <a:chExt cx="7369196" cy="5371514"/>
            </a:xfrm>
          </p:grpSpPr>
          <p:pic>
            <p:nvPicPr>
              <p:cNvPr id="9219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t="15873" r="91745" b="14962"/>
              <a:stretch/>
            </p:blipFill>
            <p:spPr bwMode="auto">
              <a:xfrm>
                <a:off x="257583" y="908720"/>
                <a:ext cx="1074057" cy="50595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4725" t="17063" r="60957" b="10416"/>
              <a:stretch/>
            </p:blipFill>
            <p:spPr bwMode="auto">
              <a:xfrm>
                <a:off x="1259632" y="975262"/>
                <a:ext cx="3164114" cy="53049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" name="Picture 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4725" t="20075" r="60621" b="13095"/>
              <a:stretch/>
            </p:blipFill>
            <p:spPr bwMode="auto">
              <a:xfrm>
                <a:off x="4419122" y="1025026"/>
                <a:ext cx="3207657" cy="48886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7" name="TextBox 6"/>
            <p:cNvSpPr txBox="1"/>
            <p:nvPr/>
          </p:nvSpPr>
          <p:spPr>
            <a:xfrm>
              <a:off x="866886" y="6034013"/>
              <a:ext cx="386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77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433706" y="5968268"/>
              <a:ext cx="386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48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11560" y="5919663"/>
            <a:ext cx="778379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orting data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1: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mino acid alignment of EPSPS encoding genes from various organisms by using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lustalW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rogramm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3942575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38</Words>
  <Application>Microsoft Office PowerPoint</Application>
  <PresentationFormat>On-screen Show (4:3)</PresentationFormat>
  <Paragraphs>20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arti GARG</dc:creator>
  <cp:lastModifiedBy>N Tuteja</cp:lastModifiedBy>
  <cp:revision>18</cp:revision>
  <dcterms:created xsi:type="dcterms:W3CDTF">2013-10-29T13:43:05Z</dcterms:created>
  <dcterms:modified xsi:type="dcterms:W3CDTF">2013-10-30T07:21:28Z</dcterms:modified>
</cp:coreProperties>
</file>